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5" r:id="rId3"/>
    <p:sldId id="268" r:id="rId4"/>
    <p:sldId id="269" r:id="rId5"/>
    <p:sldId id="270" r:id="rId6"/>
    <p:sldId id="266" r:id="rId7"/>
    <p:sldId id="267" r:id="rId8"/>
    <p:sldId id="271" r:id="rId9"/>
  </p:sldIdLst>
  <p:sldSz cx="6858000" cy="9906000" type="A4"/>
  <p:notesSz cx="6797675" cy="992822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6DEB5"/>
    <a:srgbClr val="C6ACD9"/>
    <a:srgbClr val="FFE699"/>
    <a:srgbClr val="F8CBAD"/>
    <a:srgbClr val="BDD7EE"/>
    <a:srgbClr val="00FF0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983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374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4599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1116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9884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3849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3533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5663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876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3345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30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710BA-0570-48EC-8F5B-21FF6BD65BBD}" type="datetimeFigureOut">
              <a:rPr lang="zh-CN" altLang="en-US" smtClean="0"/>
              <a:t>2023/6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14F29-6A1D-4FA6-8A71-89BC95EFD6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4292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1143" t="33524" r="41500" b="22032"/>
          <a:stretch/>
        </p:blipFill>
        <p:spPr>
          <a:xfrm>
            <a:off x="129045" y="1033153"/>
            <a:ext cx="6675122" cy="290945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29045" y="4120738"/>
            <a:ext cx="6675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1. Sequence logos of conserved motifs in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BnaPCO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The logo indicated the sequence of eight motifs. A letter represented an amino acid, and the size represented its conservation at this position.  </a:t>
            </a:r>
          </a:p>
        </p:txBody>
      </p:sp>
    </p:spTree>
    <p:extLst>
      <p:ext uri="{BB962C8B-B14F-4D97-AF65-F5344CB8AC3E}">
        <p14:creationId xmlns:p14="http://schemas.microsoft.com/office/powerpoint/2010/main" val="3735400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38524"/>
            <a:ext cx="6858000" cy="3308684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721225" y="5447208"/>
            <a:ext cx="391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CO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DS sequence alignme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506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583464"/>
            <a:ext cx="6858000" cy="210552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739153" y="5745344"/>
            <a:ext cx="391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CO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DS sequence alignme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587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32373"/>
            <a:ext cx="6858000" cy="330868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751028" y="4741057"/>
            <a:ext cx="391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CO3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DS sequence alignme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36278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69278"/>
            <a:ext cx="6858000" cy="240631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745129" y="4775594"/>
            <a:ext cx="391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CO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DS sequence alignme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63990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82056"/>
            <a:ext cx="6858000" cy="2646947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745129" y="4829003"/>
            <a:ext cx="391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CO5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DS sequence alignme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77628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97394" y="3404949"/>
            <a:ext cx="391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7. PCO4 protein sequence alignme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0" y="2261949"/>
            <a:ext cx="6858000" cy="1143000"/>
            <a:chOff x="0" y="1668183"/>
            <a:chExt cx="6858000" cy="11430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668183"/>
              <a:ext cx="6858000" cy="1143000"/>
            </a:xfrm>
            <a:prstGeom prst="rect">
              <a:avLst/>
            </a:prstGeom>
          </p:spPr>
        </p:pic>
        <p:sp>
          <p:nvSpPr>
            <p:cNvPr id="4" name="矩形 3"/>
            <p:cNvSpPr/>
            <p:nvPr/>
          </p:nvSpPr>
          <p:spPr>
            <a:xfrm>
              <a:off x="768842" y="2213221"/>
              <a:ext cx="2700000" cy="52690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284635"/>
            <a:ext cx="6858000" cy="1336729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697394" y="5678508"/>
            <a:ext cx="391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8. PCO3 protein sequence alignmen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245567" y="4265975"/>
            <a:ext cx="3215951" cy="57972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1974980" y="4965438"/>
            <a:ext cx="2640563" cy="64348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5752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1343" y="371475"/>
            <a:ext cx="5681964" cy="6962235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66128" y="7522525"/>
            <a:ext cx="652574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9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pression pattern of </a:t>
            </a:r>
            <a:r>
              <a:rPr lang="en-US" altLang="zh-CN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PCOs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aPCOs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n different tissues by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PCR assays.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oPCO1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a and b, purpl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BoPCO2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c, yellow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BoPCO3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, gree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BoPCO4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e and f, orange),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oPCO5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g and h, blue),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raPCO1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j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urple),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raPCO2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k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yellow),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raPCO3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l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reen),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raPCO4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m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range),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raPCO5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n and o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lue) were represented in different colors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RNA levels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zh-CN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eracea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altLang="zh-CN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pa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ormalized to </a:t>
            </a:r>
            <a:r>
              <a:rPr lang="en-US" altLang="zh-CN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Actin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o5G045950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aGAPDH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raA06G00973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spectively. Bars indicated ± SD (n = 3).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0190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2</TotalTime>
  <Words>212</Words>
  <Application>Microsoft Office PowerPoint</Application>
  <PresentationFormat>A4 纸张(210x297 毫米)</PresentationFormat>
  <Paragraphs>9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卞潇华</dc:creator>
  <cp:lastModifiedBy>卞潇华</cp:lastModifiedBy>
  <cp:revision>44</cp:revision>
  <cp:lastPrinted>2023-05-04T08:27:49Z</cp:lastPrinted>
  <dcterms:created xsi:type="dcterms:W3CDTF">2023-04-18T09:36:16Z</dcterms:created>
  <dcterms:modified xsi:type="dcterms:W3CDTF">2023-06-30T09:13:51Z</dcterms:modified>
</cp:coreProperties>
</file>